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46304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74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28800" y="1346836"/>
            <a:ext cx="109728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4322446"/>
            <a:ext cx="109728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173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823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0" y="438150"/>
            <a:ext cx="315468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0" y="438150"/>
            <a:ext cx="9281160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993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899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0" y="2051686"/>
            <a:ext cx="1261872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0" y="5507356"/>
            <a:ext cx="1261872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989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190750"/>
            <a:ext cx="621792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190750"/>
            <a:ext cx="621792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680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438150"/>
            <a:ext cx="1261872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6" y="2017396"/>
            <a:ext cx="6189344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6" y="3006090"/>
            <a:ext cx="618934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0" y="2017396"/>
            <a:ext cx="6219826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0" y="3006090"/>
            <a:ext cx="6219826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599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8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138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48640"/>
            <a:ext cx="4718684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184911"/>
            <a:ext cx="740664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468880"/>
            <a:ext cx="4718684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491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48640"/>
            <a:ext cx="4718684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184911"/>
            <a:ext cx="740664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468880"/>
            <a:ext cx="4718684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981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438150"/>
            <a:ext cx="1261872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190750"/>
            <a:ext cx="1261872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7627621"/>
            <a:ext cx="32918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A0FE9-9CC2-4DFF-98E7-813086A7931E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7627621"/>
            <a:ext cx="493776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7627621"/>
            <a:ext cx="32918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76A5FC-1A83-4D63-81EF-A87B130D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87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FE4F4E0-B8BD-8562-FE65-2BECB8CE7149}"/>
              </a:ext>
            </a:extLst>
          </p:cNvPr>
          <p:cNvSpPr txBox="1"/>
          <p:nvPr/>
        </p:nvSpPr>
        <p:spPr>
          <a:xfrm>
            <a:off x="451987" y="5287178"/>
            <a:ext cx="67797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6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nel plot for the composite of heart failure hospitalization or cardiovascular mortality</a:t>
            </a:r>
            <a:endParaRPr lang="en-US" altLang="en-US" sz="5400" dirty="0">
              <a:latin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D6B1A2-4FB4-1D5D-CD8E-0068E88A2F5B}"/>
              </a:ext>
            </a:extLst>
          </p:cNvPr>
          <p:cNvSpPr txBox="1"/>
          <p:nvPr/>
        </p:nvSpPr>
        <p:spPr>
          <a:xfrm>
            <a:off x="7530973" y="5287178"/>
            <a:ext cx="67797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6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nel plot for heart failure hospitalization </a:t>
            </a:r>
            <a:endParaRPr lang="en-US" altLang="en-US" sz="5400" dirty="0">
              <a:latin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457E9BC-5BDE-0AC6-615B-314A65C607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1780" y="879610"/>
            <a:ext cx="6358689" cy="42391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736142A-9B18-E1A7-E0E2-B2B36DC81C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68" y="975862"/>
            <a:ext cx="6725653" cy="4142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4883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</TotalTime>
  <Words>1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amed</dc:creator>
  <cp:lastModifiedBy>Mohamed Hamed</cp:lastModifiedBy>
  <cp:revision>4</cp:revision>
  <dcterms:created xsi:type="dcterms:W3CDTF">2023-01-24T00:57:07Z</dcterms:created>
  <dcterms:modified xsi:type="dcterms:W3CDTF">2023-02-09T03:57:58Z</dcterms:modified>
</cp:coreProperties>
</file>